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784975" cy="992346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ropbox\Heart%20HELP\5%20App&#44060;&#48156;\6.%20My%20HeartHELP%20&#53440;&#45817;&#49457;%20&#50672;&#44396;\9%20data\2%20&#53440;&#45817;&#49457;&#50672;&#44396;\rawdata\Figure%201_MyHeartHELP_&#52280;&#50668;&#50984;_202404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945-40DB-BF3A-BBDB53602B5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945-40DB-BF3A-BBDB53602B57}"/>
              </c:ext>
            </c:extLst>
          </c:dPt>
          <c:dPt>
            <c:idx val="2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945-40DB-BF3A-BBDB53602B57}"/>
              </c:ext>
            </c:extLst>
          </c:dPt>
          <c:dPt>
            <c:idx val="3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945-40DB-BF3A-BBDB53602B57}"/>
              </c:ext>
            </c:extLst>
          </c:dPt>
          <c:dPt>
            <c:idx val="4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945-40DB-BF3A-BBDB53602B57}"/>
              </c:ext>
            </c:extLst>
          </c:dPt>
          <c:dPt>
            <c:idx val="5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945-40DB-BF3A-BBDB53602B57}"/>
              </c:ext>
            </c:extLst>
          </c:dPt>
          <c:dPt>
            <c:idx val="6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945-40DB-BF3A-BBDB53602B57}"/>
              </c:ext>
            </c:extLst>
          </c:dPt>
          <c:dPt>
            <c:idx val="7"/>
            <c:invertIfNegative val="0"/>
            <c:bubble3D val="0"/>
            <c:spPr>
              <a:pattFill prst="dkDn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 w="9525">
                <a:solidFill>
                  <a:srgbClr val="BFBFB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945-40DB-BF3A-BBDB53602B57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E945-40DB-BF3A-BBDB53602B57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E945-40DB-BF3A-BBDB53602B57}"/>
              </c:ext>
            </c:extLst>
          </c:dPt>
          <c:dPt>
            <c:idx val="10"/>
            <c:invertIfNegative val="0"/>
            <c:bubble3D val="0"/>
            <c:spPr>
              <a:pattFill prst="pct50">
                <a:fgClr>
                  <a:schemeClr val="tx1">
                    <a:lumMod val="75000"/>
                    <a:lumOff val="2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945-40DB-BF3A-BBDB53602B57}"/>
              </c:ext>
            </c:extLst>
          </c:dPt>
          <c:dLbls>
            <c:dLbl>
              <c:idx val="0"/>
              <c:layout>
                <c:manualLayout>
                  <c:x val="0"/>
                  <c:y val="-0.34670603350742929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945-40DB-BF3A-BBDB53602B57}"/>
                </c:ext>
              </c:extLst>
            </c:dLbl>
            <c:dLbl>
              <c:idx val="1"/>
              <c:layout>
                <c:manualLayout>
                  <c:x val="-2.8804814874722925E-17"/>
                  <c:y val="-0.3335399816020839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945-40DB-BF3A-BBDB53602B57}"/>
                </c:ext>
              </c:extLst>
            </c:dLbl>
            <c:dLbl>
              <c:idx val="2"/>
              <c:layout>
                <c:manualLayout>
                  <c:x val="0"/>
                  <c:y val="-0.34670603350742929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E945-40DB-BF3A-BBDB53602B57}"/>
                </c:ext>
              </c:extLst>
            </c:dLbl>
            <c:dLbl>
              <c:idx val="3"/>
              <c:layout>
                <c:manualLayout>
                  <c:x val="0"/>
                  <c:y val="-0.34231734953898085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E945-40DB-BF3A-BBDB53602B57}"/>
                </c:ext>
              </c:extLst>
            </c:dLbl>
            <c:dLbl>
              <c:idx val="4"/>
              <c:layout>
                <c:manualLayout>
                  <c:x val="-5.7609629749445851E-17"/>
                  <c:y val="-0.34231734953898085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E945-40DB-BF3A-BBDB53602B57}"/>
                </c:ext>
              </c:extLst>
            </c:dLbl>
            <c:dLbl>
              <c:idx val="5"/>
              <c:layout>
                <c:manualLayout>
                  <c:x val="0"/>
                  <c:y val="-0.34231734953898085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E945-40DB-BF3A-BBDB53602B57}"/>
                </c:ext>
              </c:extLst>
            </c:dLbl>
            <c:dLbl>
              <c:idx val="6"/>
              <c:layout>
                <c:manualLayout>
                  <c:x val="0"/>
                  <c:y val="-0.34231734953898085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E945-40DB-BF3A-BBDB53602B57}"/>
                </c:ext>
              </c:extLst>
            </c:dLbl>
            <c:dLbl>
              <c:idx val="7"/>
              <c:layout>
                <c:manualLayout>
                  <c:x val="0"/>
                  <c:y val="-0.33792866557053236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E945-40DB-BF3A-BBDB53602B57}"/>
                </c:ext>
              </c:extLst>
            </c:dLbl>
            <c:dLbl>
              <c:idx val="8"/>
              <c:layout>
                <c:manualLayout>
                  <c:x val="0"/>
                  <c:y val="-0.34670603350742929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E945-40DB-BF3A-BBDB53602B57}"/>
                </c:ext>
              </c:extLst>
            </c:dLbl>
            <c:dLbl>
              <c:idx val="9"/>
              <c:layout>
                <c:manualLayout>
                  <c:x val="0"/>
                  <c:y val="-0.34231734953898085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E945-40DB-BF3A-BBDB53602B57}"/>
                </c:ext>
              </c:extLst>
            </c:dLbl>
            <c:dLbl>
              <c:idx val="10"/>
              <c:layout>
                <c:manualLayout>
                  <c:x val="0"/>
                  <c:y val="-0.25454367017001139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E945-40DB-BF3A-BBDB53602B57}"/>
                </c:ext>
              </c:extLst>
            </c:dLbl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</c15:spPr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수정_20240412!$B$9:$L$9</c:f>
              <c:strCache>
                <c:ptCount val="11"/>
                <c:pt idx="0">
                  <c:v>Physical activity</c:v>
                </c:pt>
                <c:pt idx="1">
                  <c:v>Sedentary behavior</c:v>
                </c:pt>
                <c:pt idx="2">
                  <c:v>Fruit and vegetables</c:v>
                </c:pt>
                <c:pt idx="3">
                  <c:v>Sugar-
sweetened
 beverage</c:v>
                </c:pt>
                <c:pt idx="4">
                  <c:v>Fast food</c:v>
                </c:pt>
                <c:pt idx="5">
                  <c:v>Saturated fat 
or trans fat</c:v>
                </c:pt>
                <c:pt idx="6">
                  <c:v>Whole grain</c:v>
                </c:pt>
                <c:pt idx="7">
                  <c:v>Sodium</c:v>
                </c:pt>
                <c:pt idx="8">
                  <c:v>Current smoking</c:v>
                </c:pt>
                <c:pt idx="9">
                  <c:v>Alcohol drinking</c:v>
                </c:pt>
                <c:pt idx="10">
                  <c:v>Body weight</c:v>
                </c:pt>
              </c:strCache>
            </c:strRef>
          </c:cat>
          <c:val>
            <c:numRef>
              <c:f>수정_20240412!$B$10:$L$10</c:f>
              <c:numCache>
                <c:formatCode>0.0</c:formatCode>
                <c:ptCount val="11"/>
                <c:pt idx="0">
                  <c:v>97.41379310344827</c:v>
                </c:pt>
                <c:pt idx="1">
                  <c:v>96.551724137931032</c:v>
                </c:pt>
                <c:pt idx="2">
                  <c:v>96.551724137931032</c:v>
                </c:pt>
                <c:pt idx="3">
                  <c:v>96.305418719211815</c:v>
                </c:pt>
                <c:pt idx="4">
                  <c:v>96.305418719211815</c:v>
                </c:pt>
                <c:pt idx="5">
                  <c:v>96.305418719211815</c:v>
                </c:pt>
                <c:pt idx="6">
                  <c:v>96.551724137931032</c:v>
                </c:pt>
                <c:pt idx="7">
                  <c:v>96.059113300492612</c:v>
                </c:pt>
                <c:pt idx="8">
                  <c:v>97.435897435897431</c:v>
                </c:pt>
                <c:pt idx="9">
                  <c:v>96.103896103896105</c:v>
                </c:pt>
                <c:pt idx="10">
                  <c:v>85.8374384236453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E945-40DB-BF3A-BBDB53602B57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77"/>
        <c:overlap val="36"/>
        <c:axId val="176935504"/>
        <c:axId val="104420032"/>
      </c:barChart>
      <c:catAx>
        <c:axId val="17693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spc="-30" baseline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4420032"/>
        <c:crosses val="autoZero"/>
        <c:auto val="1"/>
        <c:lblAlgn val="ctr"/>
        <c:lblOffset val="100"/>
        <c:noMultiLvlLbl val="0"/>
      </c:catAx>
      <c:valAx>
        <c:axId val="104420032"/>
        <c:scaling>
          <c:orientation val="minMax"/>
          <c:max val="105"/>
          <c:min val="6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pPr>
                <a:r>
                  <a:rPr lang="en-US" sz="1000" dirty="0"/>
                  <a:t>% of participants who adhered,</a:t>
                </a:r>
                <a:r>
                  <a:rPr lang="en-US" sz="1000" baseline="0" dirty="0"/>
                  <a:t> daily</a:t>
                </a:r>
                <a:endParaRPr lang="ko-KR" sz="1000" dirty="0"/>
              </a:p>
            </c:rich>
          </c:tx>
          <c:layout>
            <c:manualLayout>
              <c:xMode val="edge"/>
              <c:yMode val="edge"/>
              <c:x val="1.2569518965993761E-2"/>
              <c:y val="9.4935527813543807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76935504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ea typeface="Calibri" panose="020F050202020403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0156" cy="4978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3249" y="0"/>
            <a:ext cx="2940156" cy="4978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795A15-A3AB-42DE-86AD-495CC8EAE74A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15925" y="1239838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8498" y="4775666"/>
            <a:ext cx="5427980" cy="39073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5568"/>
            <a:ext cx="2940156" cy="49789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3249" y="9425568"/>
            <a:ext cx="2940156" cy="49789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C316AF-7B39-4A39-BB50-3F35E3DD01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4953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CD2F3B9-BBE6-3BA9-0CEF-093280B764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7D82A5A1-9042-C0CE-D6D5-6E79E39414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AB63D4C-F979-CE46-97F8-AD73F8BB6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52E412A-7C81-E4A6-772B-C099D9074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E0E720D-0900-EF6E-047A-1B536DD31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7793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E85A6C-8679-1C58-EAD0-D25673E7A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FDA1687-358C-82F6-7439-EFC8E7D5BF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08F74A4-556E-1637-839B-F092F05B6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75A2120-A7C5-E39E-7A8E-87C108E65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048C2E6-13AE-E296-6BA8-5F6ECDC53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520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17F072F-435B-B61C-28DB-16CD0D8B34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3BAABAA-739C-6867-462C-496CF48B1E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7CA52A-3621-19CE-2975-5790EAD3D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41856B-AB45-32C3-3CA2-D6718375B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24F50A-6F11-ADE7-4FBD-64B328B54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9648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6D3FF2-6FCC-5DE5-241F-7CD4E0613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DA04ACB-26B6-1946-9C5F-0FC97A38C2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88C44DD-26AA-B7BB-9ACC-3404CBF86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2E453F6-2774-189D-B64D-A03C1B7FB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B9BA49-8E5B-B22E-7EF5-98268837B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497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5A0022-1189-D5B2-435D-59D1369BF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7F86F1B-9674-9635-C39F-F4EF7C8443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20C9BC9-0308-C632-7D91-0570B4F9B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65871C2-0423-7722-D5EB-700A6E2F4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8C1C26B-A8C8-4B6D-F1AC-AD15BB044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7966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C2AC862-5AF1-164E-E085-A4124D5BF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55AFC45-75F5-F4AE-DB71-E52210A665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FB66975-6583-E125-B316-746949FCC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241458D-8138-87CC-E634-1F3130363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6D43801-741B-AA49-6291-6B873E553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CB57264-5F7A-1B58-0484-835F521C7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1602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48BFF01-20CE-5118-883A-0FAAB929C0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3224DB3-5246-8073-0B6A-C14C7C5298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7F20783-D4B5-75CA-E6BA-38427D8CCF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E630997-2C9E-A300-4299-3F5012FB3F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559F63A-0080-7F0C-0CCF-94DE98665F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25F8BD9-9485-C8A1-11A9-B3BF4E21D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15E69C9-6CC4-ADA7-DF23-CEE4C556B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36AD1BE-E09F-8E18-799A-166B7E7D8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3574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9A6FA1-D98D-2164-6D21-BDF94DBEC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332CB0B-2A4D-5FEE-3EC9-E18CABBEB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E167DB5-B935-68FC-5FD8-6C1924F98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7D54CDC-1096-F4EF-2E8D-25AD2B228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1463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1A8DC00-ECBB-23FD-FB8B-535A10F51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BC781D7-AE8D-18FD-89D6-C01FE9EAD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35717E5-F206-E04E-428F-FD681BBA0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8723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651A589-2203-78BF-4037-0435BF74F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97C75D0-F04C-C823-5F0C-78C7FB234C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BEF9419-6404-1F45-A076-12CD22230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C75FEB9-AFCC-1960-8823-F1D0D6D53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1598C4A-7D03-504B-D184-E3B3F023F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0701926-A91F-B6B8-6782-0B8771486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7079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7732659-52D3-BFEB-560D-619E41FB2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F4E8117-045B-1042-B420-79EE379281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3BAB323-FF54-6748-64E9-35AC852B97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49DA751-2C35-003A-1098-8FC83017F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C38CBEE-B05F-BDAA-7285-823B8F7CA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F14E39-2514-EF8D-1364-851847DA9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8663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54EB2B5-A3AA-C241-D265-092A23A60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6CD2CE8-6D14-2E42-1CD9-21E2F6B100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DCC8D7-37FF-CAB4-A9D2-C5A57197D0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C06DA-EC9E-4711-BB16-BBC0331BEF50}" type="datetimeFigureOut">
              <a:rPr lang="ko-KR" altLang="en-US" smtClean="0"/>
              <a:t>2025-04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5AE25C-7299-DECC-3627-629ED4A76E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10FD5F2-C35F-34DA-5821-46219B84EA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5056FF-8104-4E9F-9AED-016ED058976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4168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D54EFBBF-7227-5513-910A-3C409E08F27D}"/>
              </a:ext>
            </a:extLst>
          </p:cNvPr>
          <p:cNvGrpSpPr/>
          <p:nvPr/>
        </p:nvGrpSpPr>
        <p:grpSpPr>
          <a:xfrm>
            <a:off x="2252903" y="1666618"/>
            <a:ext cx="8083046" cy="2670697"/>
            <a:chOff x="1869618" y="2044178"/>
            <a:chExt cx="8083046" cy="2670697"/>
          </a:xfrm>
        </p:grpSpPr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9F873465-3958-496B-ED4C-F121B4F37D6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05209394"/>
                </p:ext>
              </p:extLst>
            </p:nvPr>
          </p:nvGraphicFramePr>
          <p:xfrm>
            <a:off x="1869618" y="2044178"/>
            <a:ext cx="8083046" cy="26706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E33CC275-B1A4-7A8D-B1BD-0E9E41A9158C}"/>
                </a:ext>
              </a:extLst>
            </p:cNvPr>
            <p:cNvSpPr/>
            <p:nvPr/>
          </p:nvSpPr>
          <p:spPr>
            <a:xfrm>
              <a:off x="2195724" y="4065948"/>
              <a:ext cx="290935" cy="1521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093BBCFA-C962-D7BB-6111-33916F20127E}"/>
                </a:ext>
              </a:extLst>
            </p:cNvPr>
            <p:cNvSpPr/>
            <p:nvPr/>
          </p:nvSpPr>
          <p:spPr>
            <a:xfrm>
              <a:off x="2260183" y="2193821"/>
              <a:ext cx="195942" cy="1119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%</a:t>
              </a:r>
              <a:endParaRPr lang="ko-KR" altLang="en-US" sz="105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" name="자유형: 도형 7">
              <a:extLst>
                <a:ext uri="{FF2B5EF4-FFF2-40B4-BE49-F238E27FC236}">
                  <a16:creationId xmlns:a16="http://schemas.microsoft.com/office/drawing/2014/main" id="{558F1B6C-4152-1E22-B6BB-0B785D4F7889}"/>
                </a:ext>
              </a:extLst>
            </p:cNvPr>
            <p:cNvSpPr/>
            <p:nvPr/>
          </p:nvSpPr>
          <p:spPr>
            <a:xfrm>
              <a:off x="2456125" y="3723712"/>
              <a:ext cx="7389805" cy="70226"/>
            </a:xfrm>
            <a:custGeom>
              <a:avLst/>
              <a:gdLst>
                <a:gd name="connsiteX0" fmla="*/ 0 w 7871460"/>
                <a:gd name="connsiteY0" fmla="*/ 8 h 152416"/>
                <a:gd name="connsiteX1" fmla="*/ 320040 w 7871460"/>
                <a:gd name="connsiteY1" fmla="*/ 144788 h 152416"/>
                <a:gd name="connsiteX2" fmla="*/ 693420 w 7871460"/>
                <a:gd name="connsiteY2" fmla="*/ 8 h 152416"/>
                <a:gd name="connsiteX3" fmla="*/ 1059180 w 7871460"/>
                <a:gd name="connsiteY3" fmla="*/ 144788 h 152416"/>
                <a:gd name="connsiteX4" fmla="*/ 1409700 w 7871460"/>
                <a:gd name="connsiteY4" fmla="*/ 7628 h 152416"/>
                <a:gd name="connsiteX5" fmla="*/ 1767840 w 7871460"/>
                <a:gd name="connsiteY5" fmla="*/ 144788 h 152416"/>
                <a:gd name="connsiteX6" fmla="*/ 2118360 w 7871460"/>
                <a:gd name="connsiteY6" fmla="*/ 7628 h 152416"/>
                <a:gd name="connsiteX7" fmla="*/ 2484120 w 7871460"/>
                <a:gd name="connsiteY7" fmla="*/ 152408 h 152416"/>
                <a:gd name="connsiteX8" fmla="*/ 2842260 w 7871460"/>
                <a:gd name="connsiteY8" fmla="*/ 15248 h 152416"/>
                <a:gd name="connsiteX9" fmla="*/ 3200400 w 7871460"/>
                <a:gd name="connsiteY9" fmla="*/ 144788 h 152416"/>
                <a:gd name="connsiteX10" fmla="*/ 3566160 w 7871460"/>
                <a:gd name="connsiteY10" fmla="*/ 15248 h 152416"/>
                <a:gd name="connsiteX11" fmla="*/ 3916680 w 7871460"/>
                <a:gd name="connsiteY11" fmla="*/ 144788 h 152416"/>
                <a:gd name="connsiteX12" fmla="*/ 4282440 w 7871460"/>
                <a:gd name="connsiteY12" fmla="*/ 7628 h 152416"/>
                <a:gd name="connsiteX13" fmla="*/ 4640580 w 7871460"/>
                <a:gd name="connsiteY13" fmla="*/ 144788 h 152416"/>
                <a:gd name="connsiteX14" fmla="*/ 4998720 w 7871460"/>
                <a:gd name="connsiteY14" fmla="*/ 7628 h 152416"/>
                <a:gd name="connsiteX15" fmla="*/ 5364480 w 7871460"/>
                <a:gd name="connsiteY15" fmla="*/ 137168 h 152416"/>
                <a:gd name="connsiteX16" fmla="*/ 5722620 w 7871460"/>
                <a:gd name="connsiteY16" fmla="*/ 7628 h 152416"/>
                <a:gd name="connsiteX17" fmla="*/ 6088380 w 7871460"/>
                <a:gd name="connsiteY17" fmla="*/ 144788 h 152416"/>
                <a:gd name="connsiteX18" fmla="*/ 6438900 w 7871460"/>
                <a:gd name="connsiteY18" fmla="*/ 7628 h 152416"/>
                <a:gd name="connsiteX19" fmla="*/ 6804660 w 7871460"/>
                <a:gd name="connsiteY19" fmla="*/ 137168 h 152416"/>
                <a:gd name="connsiteX20" fmla="*/ 7155180 w 7871460"/>
                <a:gd name="connsiteY20" fmla="*/ 8 h 152416"/>
                <a:gd name="connsiteX21" fmla="*/ 7513320 w 7871460"/>
                <a:gd name="connsiteY21" fmla="*/ 144788 h 152416"/>
                <a:gd name="connsiteX22" fmla="*/ 7871460 w 7871460"/>
                <a:gd name="connsiteY22" fmla="*/ 7628 h 152416"/>
                <a:gd name="connsiteX23" fmla="*/ 7871460 w 7871460"/>
                <a:gd name="connsiteY23" fmla="*/ 7628 h 152416"/>
                <a:gd name="connsiteX0" fmla="*/ 0 w 8168640"/>
                <a:gd name="connsiteY0" fmla="*/ 8 h 152416"/>
                <a:gd name="connsiteX1" fmla="*/ 320040 w 8168640"/>
                <a:gd name="connsiteY1" fmla="*/ 144788 h 152416"/>
                <a:gd name="connsiteX2" fmla="*/ 693420 w 8168640"/>
                <a:gd name="connsiteY2" fmla="*/ 8 h 152416"/>
                <a:gd name="connsiteX3" fmla="*/ 1059180 w 8168640"/>
                <a:gd name="connsiteY3" fmla="*/ 144788 h 152416"/>
                <a:gd name="connsiteX4" fmla="*/ 1409700 w 8168640"/>
                <a:gd name="connsiteY4" fmla="*/ 7628 h 152416"/>
                <a:gd name="connsiteX5" fmla="*/ 1767840 w 8168640"/>
                <a:gd name="connsiteY5" fmla="*/ 144788 h 152416"/>
                <a:gd name="connsiteX6" fmla="*/ 2118360 w 8168640"/>
                <a:gd name="connsiteY6" fmla="*/ 7628 h 152416"/>
                <a:gd name="connsiteX7" fmla="*/ 2484120 w 8168640"/>
                <a:gd name="connsiteY7" fmla="*/ 152408 h 152416"/>
                <a:gd name="connsiteX8" fmla="*/ 2842260 w 8168640"/>
                <a:gd name="connsiteY8" fmla="*/ 15248 h 152416"/>
                <a:gd name="connsiteX9" fmla="*/ 3200400 w 8168640"/>
                <a:gd name="connsiteY9" fmla="*/ 144788 h 152416"/>
                <a:gd name="connsiteX10" fmla="*/ 3566160 w 8168640"/>
                <a:gd name="connsiteY10" fmla="*/ 15248 h 152416"/>
                <a:gd name="connsiteX11" fmla="*/ 3916680 w 8168640"/>
                <a:gd name="connsiteY11" fmla="*/ 144788 h 152416"/>
                <a:gd name="connsiteX12" fmla="*/ 4282440 w 8168640"/>
                <a:gd name="connsiteY12" fmla="*/ 7628 h 152416"/>
                <a:gd name="connsiteX13" fmla="*/ 4640580 w 8168640"/>
                <a:gd name="connsiteY13" fmla="*/ 144788 h 152416"/>
                <a:gd name="connsiteX14" fmla="*/ 4998720 w 8168640"/>
                <a:gd name="connsiteY14" fmla="*/ 7628 h 152416"/>
                <a:gd name="connsiteX15" fmla="*/ 5364480 w 8168640"/>
                <a:gd name="connsiteY15" fmla="*/ 137168 h 152416"/>
                <a:gd name="connsiteX16" fmla="*/ 5722620 w 8168640"/>
                <a:gd name="connsiteY16" fmla="*/ 7628 h 152416"/>
                <a:gd name="connsiteX17" fmla="*/ 6088380 w 8168640"/>
                <a:gd name="connsiteY17" fmla="*/ 144788 h 152416"/>
                <a:gd name="connsiteX18" fmla="*/ 6438900 w 8168640"/>
                <a:gd name="connsiteY18" fmla="*/ 7628 h 152416"/>
                <a:gd name="connsiteX19" fmla="*/ 6804660 w 8168640"/>
                <a:gd name="connsiteY19" fmla="*/ 137168 h 152416"/>
                <a:gd name="connsiteX20" fmla="*/ 7155180 w 8168640"/>
                <a:gd name="connsiteY20" fmla="*/ 8 h 152416"/>
                <a:gd name="connsiteX21" fmla="*/ 7513320 w 8168640"/>
                <a:gd name="connsiteY21" fmla="*/ 144788 h 152416"/>
                <a:gd name="connsiteX22" fmla="*/ 7871460 w 8168640"/>
                <a:gd name="connsiteY22" fmla="*/ 7628 h 152416"/>
                <a:gd name="connsiteX23" fmla="*/ 8168640 w 8168640"/>
                <a:gd name="connsiteY23" fmla="*/ 152408 h 152416"/>
                <a:gd name="connsiteX0" fmla="*/ 0 w 8251281"/>
                <a:gd name="connsiteY0" fmla="*/ 8 h 152416"/>
                <a:gd name="connsiteX1" fmla="*/ 320040 w 8251281"/>
                <a:gd name="connsiteY1" fmla="*/ 144788 h 152416"/>
                <a:gd name="connsiteX2" fmla="*/ 693420 w 8251281"/>
                <a:gd name="connsiteY2" fmla="*/ 8 h 152416"/>
                <a:gd name="connsiteX3" fmla="*/ 1059180 w 8251281"/>
                <a:gd name="connsiteY3" fmla="*/ 144788 h 152416"/>
                <a:gd name="connsiteX4" fmla="*/ 1409700 w 8251281"/>
                <a:gd name="connsiteY4" fmla="*/ 7628 h 152416"/>
                <a:gd name="connsiteX5" fmla="*/ 1767840 w 8251281"/>
                <a:gd name="connsiteY5" fmla="*/ 144788 h 152416"/>
                <a:gd name="connsiteX6" fmla="*/ 2118360 w 8251281"/>
                <a:gd name="connsiteY6" fmla="*/ 7628 h 152416"/>
                <a:gd name="connsiteX7" fmla="*/ 2484120 w 8251281"/>
                <a:gd name="connsiteY7" fmla="*/ 152408 h 152416"/>
                <a:gd name="connsiteX8" fmla="*/ 2842260 w 8251281"/>
                <a:gd name="connsiteY8" fmla="*/ 15248 h 152416"/>
                <a:gd name="connsiteX9" fmla="*/ 3200400 w 8251281"/>
                <a:gd name="connsiteY9" fmla="*/ 144788 h 152416"/>
                <a:gd name="connsiteX10" fmla="*/ 3566160 w 8251281"/>
                <a:gd name="connsiteY10" fmla="*/ 15248 h 152416"/>
                <a:gd name="connsiteX11" fmla="*/ 3916680 w 8251281"/>
                <a:gd name="connsiteY11" fmla="*/ 144788 h 152416"/>
                <a:gd name="connsiteX12" fmla="*/ 4282440 w 8251281"/>
                <a:gd name="connsiteY12" fmla="*/ 7628 h 152416"/>
                <a:gd name="connsiteX13" fmla="*/ 4640580 w 8251281"/>
                <a:gd name="connsiteY13" fmla="*/ 144788 h 152416"/>
                <a:gd name="connsiteX14" fmla="*/ 4998720 w 8251281"/>
                <a:gd name="connsiteY14" fmla="*/ 7628 h 152416"/>
                <a:gd name="connsiteX15" fmla="*/ 5364480 w 8251281"/>
                <a:gd name="connsiteY15" fmla="*/ 137168 h 152416"/>
                <a:gd name="connsiteX16" fmla="*/ 5722620 w 8251281"/>
                <a:gd name="connsiteY16" fmla="*/ 7628 h 152416"/>
                <a:gd name="connsiteX17" fmla="*/ 6088380 w 8251281"/>
                <a:gd name="connsiteY17" fmla="*/ 144788 h 152416"/>
                <a:gd name="connsiteX18" fmla="*/ 6438900 w 8251281"/>
                <a:gd name="connsiteY18" fmla="*/ 7628 h 152416"/>
                <a:gd name="connsiteX19" fmla="*/ 6804660 w 8251281"/>
                <a:gd name="connsiteY19" fmla="*/ 137168 h 152416"/>
                <a:gd name="connsiteX20" fmla="*/ 7155180 w 8251281"/>
                <a:gd name="connsiteY20" fmla="*/ 8 h 152416"/>
                <a:gd name="connsiteX21" fmla="*/ 7513320 w 8251281"/>
                <a:gd name="connsiteY21" fmla="*/ 144788 h 152416"/>
                <a:gd name="connsiteX22" fmla="*/ 7871460 w 8251281"/>
                <a:gd name="connsiteY22" fmla="*/ 7628 h 152416"/>
                <a:gd name="connsiteX23" fmla="*/ 8168640 w 8251281"/>
                <a:gd name="connsiteY23" fmla="*/ 152408 h 152416"/>
                <a:gd name="connsiteX0" fmla="*/ 0 w 8168640"/>
                <a:gd name="connsiteY0" fmla="*/ 8 h 222476"/>
                <a:gd name="connsiteX1" fmla="*/ 320040 w 8168640"/>
                <a:gd name="connsiteY1" fmla="*/ 144788 h 222476"/>
                <a:gd name="connsiteX2" fmla="*/ 693420 w 8168640"/>
                <a:gd name="connsiteY2" fmla="*/ 8 h 222476"/>
                <a:gd name="connsiteX3" fmla="*/ 1059180 w 8168640"/>
                <a:gd name="connsiteY3" fmla="*/ 144788 h 222476"/>
                <a:gd name="connsiteX4" fmla="*/ 1409700 w 8168640"/>
                <a:gd name="connsiteY4" fmla="*/ 7628 h 222476"/>
                <a:gd name="connsiteX5" fmla="*/ 1767840 w 8168640"/>
                <a:gd name="connsiteY5" fmla="*/ 144788 h 222476"/>
                <a:gd name="connsiteX6" fmla="*/ 2118360 w 8168640"/>
                <a:gd name="connsiteY6" fmla="*/ 7628 h 222476"/>
                <a:gd name="connsiteX7" fmla="*/ 2484120 w 8168640"/>
                <a:gd name="connsiteY7" fmla="*/ 152408 h 222476"/>
                <a:gd name="connsiteX8" fmla="*/ 2842260 w 8168640"/>
                <a:gd name="connsiteY8" fmla="*/ 15248 h 222476"/>
                <a:gd name="connsiteX9" fmla="*/ 3200400 w 8168640"/>
                <a:gd name="connsiteY9" fmla="*/ 144788 h 222476"/>
                <a:gd name="connsiteX10" fmla="*/ 3566160 w 8168640"/>
                <a:gd name="connsiteY10" fmla="*/ 15248 h 222476"/>
                <a:gd name="connsiteX11" fmla="*/ 3916680 w 8168640"/>
                <a:gd name="connsiteY11" fmla="*/ 144788 h 222476"/>
                <a:gd name="connsiteX12" fmla="*/ 4282440 w 8168640"/>
                <a:gd name="connsiteY12" fmla="*/ 7628 h 222476"/>
                <a:gd name="connsiteX13" fmla="*/ 4640580 w 8168640"/>
                <a:gd name="connsiteY13" fmla="*/ 144788 h 222476"/>
                <a:gd name="connsiteX14" fmla="*/ 4998720 w 8168640"/>
                <a:gd name="connsiteY14" fmla="*/ 7628 h 222476"/>
                <a:gd name="connsiteX15" fmla="*/ 5364480 w 8168640"/>
                <a:gd name="connsiteY15" fmla="*/ 137168 h 222476"/>
                <a:gd name="connsiteX16" fmla="*/ 5722620 w 8168640"/>
                <a:gd name="connsiteY16" fmla="*/ 7628 h 222476"/>
                <a:gd name="connsiteX17" fmla="*/ 6088380 w 8168640"/>
                <a:gd name="connsiteY17" fmla="*/ 144788 h 222476"/>
                <a:gd name="connsiteX18" fmla="*/ 6438900 w 8168640"/>
                <a:gd name="connsiteY18" fmla="*/ 7628 h 222476"/>
                <a:gd name="connsiteX19" fmla="*/ 6804660 w 8168640"/>
                <a:gd name="connsiteY19" fmla="*/ 137168 h 222476"/>
                <a:gd name="connsiteX20" fmla="*/ 7155180 w 8168640"/>
                <a:gd name="connsiteY20" fmla="*/ 8 h 222476"/>
                <a:gd name="connsiteX21" fmla="*/ 7513320 w 8168640"/>
                <a:gd name="connsiteY21" fmla="*/ 144788 h 222476"/>
                <a:gd name="connsiteX22" fmla="*/ 7871460 w 8168640"/>
                <a:gd name="connsiteY22" fmla="*/ 7628 h 222476"/>
                <a:gd name="connsiteX23" fmla="*/ 8168640 w 8168640"/>
                <a:gd name="connsiteY23" fmla="*/ 152408 h 222476"/>
                <a:gd name="connsiteX0" fmla="*/ 0 w 8382000"/>
                <a:gd name="connsiteY0" fmla="*/ 8 h 152416"/>
                <a:gd name="connsiteX1" fmla="*/ 320040 w 8382000"/>
                <a:gd name="connsiteY1" fmla="*/ 144788 h 152416"/>
                <a:gd name="connsiteX2" fmla="*/ 693420 w 8382000"/>
                <a:gd name="connsiteY2" fmla="*/ 8 h 152416"/>
                <a:gd name="connsiteX3" fmla="*/ 1059180 w 8382000"/>
                <a:gd name="connsiteY3" fmla="*/ 144788 h 152416"/>
                <a:gd name="connsiteX4" fmla="*/ 1409700 w 8382000"/>
                <a:gd name="connsiteY4" fmla="*/ 7628 h 152416"/>
                <a:gd name="connsiteX5" fmla="*/ 1767840 w 8382000"/>
                <a:gd name="connsiteY5" fmla="*/ 144788 h 152416"/>
                <a:gd name="connsiteX6" fmla="*/ 2118360 w 8382000"/>
                <a:gd name="connsiteY6" fmla="*/ 7628 h 152416"/>
                <a:gd name="connsiteX7" fmla="*/ 2484120 w 8382000"/>
                <a:gd name="connsiteY7" fmla="*/ 152408 h 152416"/>
                <a:gd name="connsiteX8" fmla="*/ 2842260 w 8382000"/>
                <a:gd name="connsiteY8" fmla="*/ 15248 h 152416"/>
                <a:gd name="connsiteX9" fmla="*/ 3200400 w 8382000"/>
                <a:gd name="connsiteY9" fmla="*/ 144788 h 152416"/>
                <a:gd name="connsiteX10" fmla="*/ 3566160 w 8382000"/>
                <a:gd name="connsiteY10" fmla="*/ 15248 h 152416"/>
                <a:gd name="connsiteX11" fmla="*/ 3916680 w 8382000"/>
                <a:gd name="connsiteY11" fmla="*/ 144788 h 152416"/>
                <a:gd name="connsiteX12" fmla="*/ 4282440 w 8382000"/>
                <a:gd name="connsiteY12" fmla="*/ 7628 h 152416"/>
                <a:gd name="connsiteX13" fmla="*/ 4640580 w 8382000"/>
                <a:gd name="connsiteY13" fmla="*/ 144788 h 152416"/>
                <a:gd name="connsiteX14" fmla="*/ 4998720 w 8382000"/>
                <a:gd name="connsiteY14" fmla="*/ 7628 h 152416"/>
                <a:gd name="connsiteX15" fmla="*/ 5364480 w 8382000"/>
                <a:gd name="connsiteY15" fmla="*/ 137168 h 152416"/>
                <a:gd name="connsiteX16" fmla="*/ 5722620 w 8382000"/>
                <a:gd name="connsiteY16" fmla="*/ 7628 h 152416"/>
                <a:gd name="connsiteX17" fmla="*/ 6088380 w 8382000"/>
                <a:gd name="connsiteY17" fmla="*/ 144788 h 152416"/>
                <a:gd name="connsiteX18" fmla="*/ 6438900 w 8382000"/>
                <a:gd name="connsiteY18" fmla="*/ 7628 h 152416"/>
                <a:gd name="connsiteX19" fmla="*/ 6804660 w 8382000"/>
                <a:gd name="connsiteY19" fmla="*/ 137168 h 152416"/>
                <a:gd name="connsiteX20" fmla="*/ 7155180 w 8382000"/>
                <a:gd name="connsiteY20" fmla="*/ 8 h 152416"/>
                <a:gd name="connsiteX21" fmla="*/ 7513320 w 8382000"/>
                <a:gd name="connsiteY21" fmla="*/ 144788 h 152416"/>
                <a:gd name="connsiteX22" fmla="*/ 7871460 w 8382000"/>
                <a:gd name="connsiteY22" fmla="*/ 7628 h 152416"/>
                <a:gd name="connsiteX23" fmla="*/ 8382000 w 8382000"/>
                <a:gd name="connsiteY23" fmla="*/ 22868 h 152416"/>
                <a:gd name="connsiteX0" fmla="*/ 0 w 8382000"/>
                <a:gd name="connsiteY0" fmla="*/ 8 h 189718"/>
                <a:gd name="connsiteX1" fmla="*/ 320040 w 8382000"/>
                <a:gd name="connsiteY1" fmla="*/ 144788 h 189718"/>
                <a:gd name="connsiteX2" fmla="*/ 693420 w 8382000"/>
                <a:gd name="connsiteY2" fmla="*/ 8 h 189718"/>
                <a:gd name="connsiteX3" fmla="*/ 1059180 w 8382000"/>
                <a:gd name="connsiteY3" fmla="*/ 144788 h 189718"/>
                <a:gd name="connsiteX4" fmla="*/ 1409700 w 8382000"/>
                <a:gd name="connsiteY4" fmla="*/ 7628 h 189718"/>
                <a:gd name="connsiteX5" fmla="*/ 1767840 w 8382000"/>
                <a:gd name="connsiteY5" fmla="*/ 144788 h 189718"/>
                <a:gd name="connsiteX6" fmla="*/ 2118360 w 8382000"/>
                <a:gd name="connsiteY6" fmla="*/ 7628 h 189718"/>
                <a:gd name="connsiteX7" fmla="*/ 2484120 w 8382000"/>
                <a:gd name="connsiteY7" fmla="*/ 152408 h 189718"/>
                <a:gd name="connsiteX8" fmla="*/ 2842260 w 8382000"/>
                <a:gd name="connsiteY8" fmla="*/ 15248 h 189718"/>
                <a:gd name="connsiteX9" fmla="*/ 3200400 w 8382000"/>
                <a:gd name="connsiteY9" fmla="*/ 144788 h 189718"/>
                <a:gd name="connsiteX10" fmla="*/ 3566160 w 8382000"/>
                <a:gd name="connsiteY10" fmla="*/ 15248 h 189718"/>
                <a:gd name="connsiteX11" fmla="*/ 3916680 w 8382000"/>
                <a:gd name="connsiteY11" fmla="*/ 144788 h 189718"/>
                <a:gd name="connsiteX12" fmla="*/ 4282440 w 8382000"/>
                <a:gd name="connsiteY12" fmla="*/ 7628 h 189718"/>
                <a:gd name="connsiteX13" fmla="*/ 4640580 w 8382000"/>
                <a:gd name="connsiteY13" fmla="*/ 144788 h 189718"/>
                <a:gd name="connsiteX14" fmla="*/ 4998720 w 8382000"/>
                <a:gd name="connsiteY14" fmla="*/ 7628 h 189718"/>
                <a:gd name="connsiteX15" fmla="*/ 5364480 w 8382000"/>
                <a:gd name="connsiteY15" fmla="*/ 137168 h 189718"/>
                <a:gd name="connsiteX16" fmla="*/ 5722620 w 8382000"/>
                <a:gd name="connsiteY16" fmla="*/ 7628 h 189718"/>
                <a:gd name="connsiteX17" fmla="*/ 6088380 w 8382000"/>
                <a:gd name="connsiteY17" fmla="*/ 144788 h 189718"/>
                <a:gd name="connsiteX18" fmla="*/ 6438900 w 8382000"/>
                <a:gd name="connsiteY18" fmla="*/ 7628 h 189718"/>
                <a:gd name="connsiteX19" fmla="*/ 6804660 w 8382000"/>
                <a:gd name="connsiteY19" fmla="*/ 137168 h 189718"/>
                <a:gd name="connsiteX20" fmla="*/ 7155180 w 8382000"/>
                <a:gd name="connsiteY20" fmla="*/ 8 h 189718"/>
                <a:gd name="connsiteX21" fmla="*/ 7513320 w 8382000"/>
                <a:gd name="connsiteY21" fmla="*/ 144788 h 189718"/>
                <a:gd name="connsiteX22" fmla="*/ 7871460 w 8382000"/>
                <a:gd name="connsiteY22" fmla="*/ 7628 h 189718"/>
                <a:gd name="connsiteX23" fmla="*/ 8382000 w 8382000"/>
                <a:gd name="connsiteY23" fmla="*/ 22868 h 189718"/>
                <a:gd name="connsiteX0" fmla="*/ 0 w 8382000"/>
                <a:gd name="connsiteY0" fmla="*/ 8 h 159307"/>
                <a:gd name="connsiteX1" fmla="*/ 320040 w 8382000"/>
                <a:gd name="connsiteY1" fmla="*/ 144788 h 159307"/>
                <a:gd name="connsiteX2" fmla="*/ 693420 w 8382000"/>
                <a:gd name="connsiteY2" fmla="*/ 8 h 159307"/>
                <a:gd name="connsiteX3" fmla="*/ 1059180 w 8382000"/>
                <a:gd name="connsiteY3" fmla="*/ 144788 h 159307"/>
                <a:gd name="connsiteX4" fmla="*/ 1409700 w 8382000"/>
                <a:gd name="connsiteY4" fmla="*/ 7628 h 159307"/>
                <a:gd name="connsiteX5" fmla="*/ 1767840 w 8382000"/>
                <a:gd name="connsiteY5" fmla="*/ 144788 h 159307"/>
                <a:gd name="connsiteX6" fmla="*/ 2118360 w 8382000"/>
                <a:gd name="connsiteY6" fmla="*/ 7628 h 159307"/>
                <a:gd name="connsiteX7" fmla="*/ 2484120 w 8382000"/>
                <a:gd name="connsiteY7" fmla="*/ 152408 h 159307"/>
                <a:gd name="connsiteX8" fmla="*/ 2842260 w 8382000"/>
                <a:gd name="connsiteY8" fmla="*/ 15248 h 159307"/>
                <a:gd name="connsiteX9" fmla="*/ 3200400 w 8382000"/>
                <a:gd name="connsiteY9" fmla="*/ 144788 h 159307"/>
                <a:gd name="connsiteX10" fmla="*/ 3566160 w 8382000"/>
                <a:gd name="connsiteY10" fmla="*/ 15248 h 159307"/>
                <a:gd name="connsiteX11" fmla="*/ 3916680 w 8382000"/>
                <a:gd name="connsiteY11" fmla="*/ 144788 h 159307"/>
                <a:gd name="connsiteX12" fmla="*/ 4282440 w 8382000"/>
                <a:gd name="connsiteY12" fmla="*/ 7628 h 159307"/>
                <a:gd name="connsiteX13" fmla="*/ 4640580 w 8382000"/>
                <a:gd name="connsiteY13" fmla="*/ 144788 h 159307"/>
                <a:gd name="connsiteX14" fmla="*/ 4998720 w 8382000"/>
                <a:gd name="connsiteY14" fmla="*/ 7628 h 159307"/>
                <a:gd name="connsiteX15" fmla="*/ 5364480 w 8382000"/>
                <a:gd name="connsiteY15" fmla="*/ 137168 h 159307"/>
                <a:gd name="connsiteX16" fmla="*/ 5722620 w 8382000"/>
                <a:gd name="connsiteY16" fmla="*/ 7628 h 159307"/>
                <a:gd name="connsiteX17" fmla="*/ 6088380 w 8382000"/>
                <a:gd name="connsiteY17" fmla="*/ 144788 h 159307"/>
                <a:gd name="connsiteX18" fmla="*/ 6438900 w 8382000"/>
                <a:gd name="connsiteY18" fmla="*/ 7628 h 159307"/>
                <a:gd name="connsiteX19" fmla="*/ 6804660 w 8382000"/>
                <a:gd name="connsiteY19" fmla="*/ 137168 h 159307"/>
                <a:gd name="connsiteX20" fmla="*/ 7155180 w 8382000"/>
                <a:gd name="connsiteY20" fmla="*/ 8 h 159307"/>
                <a:gd name="connsiteX21" fmla="*/ 7513320 w 8382000"/>
                <a:gd name="connsiteY21" fmla="*/ 144788 h 159307"/>
                <a:gd name="connsiteX22" fmla="*/ 7871460 w 8382000"/>
                <a:gd name="connsiteY22" fmla="*/ 7628 h 159307"/>
                <a:gd name="connsiteX23" fmla="*/ 8382000 w 8382000"/>
                <a:gd name="connsiteY23" fmla="*/ 22868 h 159307"/>
                <a:gd name="connsiteX0" fmla="*/ 0 w 8382000"/>
                <a:gd name="connsiteY0" fmla="*/ 8 h 155929"/>
                <a:gd name="connsiteX1" fmla="*/ 320040 w 8382000"/>
                <a:gd name="connsiteY1" fmla="*/ 144788 h 155929"/>
                <a:gd name="connsiteX2" fmla="*/ 693420 w 8382000"/>
                <a:gd name="connsiteY2" fmla="*/ 8 h 155929"/>
                <a:gd name="connsiteX3" fmla="*/ 1059180 w 8382000"/>
                <a:gd name="connsiteY3" fmla="*/ 144788 h 155929"/>
                <a:gd name="connsiteX4" fmla="*/ 1409700 w 8382000"/>
                <a:gd name="connsiteY4" fmla="*/ 7628 h 155929"/>
                <a:gd name="connsiteX5" fmla="*/ 1767840 w 8382000"/>
                <a:gd name="connsiteY5" fmla="*/ 144788 h 155929"/>
                <a:gd name="connsiteX6" fmla="*/ 2118360 w 8382000"/>
                <a:gd name="connsiteY6" fmla="*/ 7628 h 155929"/>
                <a:gd name="connsiteX7" fmla="*/ 2484120 w 8382000"/>
                <a:gd name="connsiteY7" fmla="*/ 152408 h 155929"/>
                <a:gd name="connsiteX8" fmla="*/ 2842260 w 8382000"/>
                <a:gd name="connsiteY8" fmla="*/ 15248 h 155929"/>
                <a:gd name="connsiteX9" fmla="*/ 3200400 w 8382000"/>
                <a:gd name="connsiteY9" fmla="*/ 144788 h 155929"/>
                <a:gd name="connsiteX10" fmla="*/ 3566160 w 8382000"/>
                <a:gd name="connsiteY10" fmla="*/ 15248 h 155929"/>
                <a:gd name="connsiteX11" fmla="*/ 3916680 w 8382000"/>
                <a:gd name="connsiteY11" fmla="*/ 144788 h 155929"/>
                <a:gd name="connsiteX12" fmla="*/ 4282440 w 8382000"/>
                <a:gd name="connsiteY12" fmla="*/ 7628 h 155929"/>
                <a:gd name="connsiteX13" fmla="*/ 4640580 w 8382000"/>
                <a:gd name="connsiteY13" fmla="*/ 144788 h 155929"/>
                <a:gd name="connsiteX14" fmla="*/ 4998720 w 8382000"/>
                <a:gd name="connsiteY14" fmla="*/ 7628 h 155929"/>
                <a:gd name="connsiteX15" fmla="*/ 5364480 w 8382000"/>
                <a:gd name="connsiteY15" fmla="*/ 137168 h 155929"/>
                <a:gd name="connsiteX16" fmla="*/ 5722620 w 8382000"/>
                <a:gd name="connsiteY16" fmla="*/ 7628 h 155929"/>
                <a:gd name="connsiteX17" fmla="*/ 6088380 w 8382000"/>
                <a:gd name="connsiteY17" fmla="*/ 144788 h 155929"/>
                <a:gd name="connsiteX18" fmla="*/ 6438900 w 8382000"/>
                <a:gd name="connsiteY18" fmla="*/ 7628 h 155929"/>
                <a:gd name="connsiteX19" fmla="*/ 6804660 w 8382000"/>
                <a:gd name="connsiteY19" fmla="*/ 137168 h 155929"/>
                <a:gd name="connsiteX20" fmla="*/ 7155180 w 8382000"/>
                <a:gd name="connsiteY20" fmla="*/ 8 h 155929"/>
                <a:gd name="connsiteX21" fmla="*/ 7513320 w 8382000"/>
                <a:gd name="connsiteY21" fmla="*/ 144788 h 155929"/>
                <a:gd name="connsiteX22" fmla="*/ 7871460 w 8382000"/>
                <a:gd name="connsiteY22" fmla="*/ 7628 h 155929"/>
                <a:gd name="connsiteX23" fmla="*/ 8382000 w 8382000"/>
                <a:gd name="connsiteY23" fmla="*/ 22868 h 155929"/>
                <a:gd name="connsiteX0" fmla="*/ 0 w 8420100"/>
                <a:gd name="connsiteY0" fmla="*/ 8 h 162051"/>
                <a:gd name="connsiteX1" fmla="*/ 320040 w 8420100"/>
                <a:gd name="connsiteY1" fmla="*/ 144788 h 162051"/>
                <a:gd name="connsiteX2" fmla="*/ 693420 w 8420100"/>
                <a:gd name="connsiteY2" fmla="*/ 8 h 162051"/>
                <a:gd name="connsiteX3" fmla="*/ 1059180 w 8420100"/>
                <a:gd name="connsiteY3" fmla="*/ 144788 h 162051"/>
                <a:gd name="connsiteX4" fmla="*/ 1409700 w 8420100"/>
                <a:gd name="connsiteY4" fmla="*/ 7628 h 162051"/>
                <a:gd name="connsiteX5" fmla="*/ 1767840 w 8420100"/>
                <a:gd name="connsiteY5" fmla="*/ 144788 h 162051"/>
                <a:gd name="connsiteX6" fmla="*/ 2118360 w 8420100"/>
                <a:gd name="connsiteY6" fmla="*/ 7628 h 162051"/>
                <a:gd name="connsiteX7" fmla="*/ 2484120 w 8420100"/>
                <a:gd name="connsiteY7" fmla="*/ 152408 h 162051"/>
                <a:gd name="connsiteX8" fmla="*/ 2842260 w 8420100"/>
                <a:gd name="connsiteY8" fmla="*/ 15248 h 162051"/>
                <a:gd name="connsiteX9" fmla="*/ 3200400 w 8420100"/>
                <a:gd name="connsiteY9" fmla="*/ 144788 h 162051"/>
                <a:gd name="connsiteX10" fmla="*/ 3566160 w 8420100"/>
                <a:gd name="connsiteY10" fmla="*/ 15248 h 162051"/>
                <a:gd name="connsiteX11" fmla="*/ 3916680 w 8420100"/>
                <a:gd name="connsiteY11" fmla="*/ 144788 h 162051"/>
                <a:gd name="connsiteX12" fmla="*/ 4282440 w 8420100"/>
                <a:gd name="connsiteY12" fmla="*/ 7628 h 162051"/>
                <a:gd name="connsiteX13" fmla="*/ 4640580 w 8420100"/>
                <a:gd name="connsiteY13" fmla="*/ 144788 h 162051"/>
                <a:gd name="connsiteX14" fmla="*/ 4998720 w 8420100"/>
                <a:gd name="connsiteY14" fmla="*/ 7628 h 162051"/>
                <a:gd name="connsiteX15" fmla="*/ 5364480 w 8420100"/>
                <a:gd name="connsiteY15" fmla="*/ 137168 h 162051"/>
                <a:gd name="connsiteX16" fmla="*/ 5722620 w 8420100"/>
                <a:gd name="connsiteY16" fmla="*/ 7628 h 162051"/>
                <a:gd name="connsiteX17" fmla="*/ 6088380 w 8420100"/>
                <a:gd name="connsiteY17" fmla="*/ 144788 h 162051"/>
                <a:gd name="connsiteX18" fmla="*/ 6438900 w 8420100"/>
                <a:gd name="connsiteY18" fmla="*/ 7628 h 162051"/>
                <a:gd name="connsiteX19" fmla="*/ 6804660 w 8420100"/>
                <a:gd name="connsiteY19" fmla="*/ 137168 h 162051"/>
                <a:gd name="connsiteX20" fmla="*/ 7155180 w 8420100"/>
                <a:gd name="connsiteY20" fmla="*/ 8 h 162051"/>
                <a:gd name="connsiteX21" fmla="*/ 7513320 w 8420100"/>
                <a:gd name="connsiteY21" fmla="*/ 144788 h 162051"/>
                <a:gd name="connsiteX22" fmla="*/ 7871460 w 8420100"/>
                <a:gd name="connsiteY22" fmla="*/ 7628 h 162051"/>
                <a:gd name="connsiteX23" fmla="*/ 8420100 w 8420100"/>
                <a:gd name="connsiteY23" fmla="*/ 30488 h 162051"/>
                <a:gd name="connsiteX0" fmla="*/ 0 w 8420100"/>
                <a:gd name="connsiteY0" fmla="*/ 8 h 175547"/>
                <a:gd name="connsiteX1" fmla="*/ 320040 w 8420100"/>
                <a:gd name="connsiteY1" fmla="*/ 144788 h 175547"/>
                <a:gd name="connsiteX2" fmla="*/ 693420 w 8420100"/>
                <a:gd name="connsiteY2" fmla="*/ 8 h 175547"/>
                <a:gd name="connsiteX3" fmla="*/ 1059180 w 8420100"/>
                <a:gd name="connsiteY3" fmla="*/ 144788 h 175547"/>
                <a:gd name="connsiteX4" fmla="*/ 1409700 w 8420100"/>
                <a:gd name="connsiteY4" fmla="*/ 7628 h 175547"/>
                <a:gd name="connsiteX5" fmla="*/ 1767840 w 8420100"/>
                <a:gd name="connsiteY5" fmla="*/ 144788 h 175547"/>
                <a:gd name="connsiteX6" fmla="*/ 2118360 w 8420100"/>
                <a:gd name="connsiteY6" fmla="*/ 7628 h 175547"/>
                <a:gd name="connsiteX7" fmla="*/ 2484120 w 8420100"/>
                <a:gd name="connsiteY7" fmla="*/ 152408 h 175547"/>
                <a:gd name="connsiteX8" fmla="*/ 2842260 w 8420100"/>
                <a:gd name="connsiteY8" fmla="*/ 15248 h 175547"/>
                <a:gd name="connsiteX9" fmla="*/ 3200400 w 8420100"/>
                <a:gd name="connsiteY9" fmla="*/ 144788 h 175547"/>
                <a:gd name="connsiteX10" fmla="*/ 3566160 w 8420100"/>
                <a:gd name="connsiteY10" fmla="*/ 15248 h 175547"/>
                <a:gd name="connsiteX11" fmla="*/ 3916680 w 8420100"/>
                <a:gd name="connsiteY11" fmla="*/ 144788 h 175547"/>
                <a:gd name="connsiteX12" fmla="*/ 4282440 w 8420100"/>
                <a:gd name="connsiteY12" fmla="*/ 7628 h 175547"/>
                <a:gd name="connsiteX13" fmla="*/ 4640580 w 8420100"/>
                <a:gd name="connsiteY13" fmla="*/ 144788 h 175547"/>
                <a:gd name="connsiteX14" fmla="*/ 4998720 w 8420100"/>
                <a:gd name="connsiteY14" fmla="*/ 7628 h 175547"/>
                <a:gd name="connsiteX15" fmla="*/ 5364480 w 8420100"/>
                <a:gd name="connsiteY15" fmla="*/ 137168 h 175547"/>
                <a:gd name="connsiteX16" fmla="*/ 5722620 w 8420100"/>
                <a:gd name="connsiteY16" fmla="*/ 7628 h 175547"/>
                <a:gd name="connsiteX17" fmla="*/ 6088380 w 8420100"/>
                <a:gd name="connsiteY17" fmla="*/ 144788 h 175547"/>
                <a:gd name="connsiteX18" fmla="*/ 6438900 w 8420100"/>
                <a:gd name="connsiteY18" fmla="*/ 7628 h 175547"/>
                <a:gd name="connsiteX19" fmla="*/ 6804660 w 8420100"/>
                <a:gd name="connsiteY19" fmla="*/ 137168 h 175547"/>
                <a:gd name="connsiteX20" fmla="*/ 7155180 w 8420100"/>
                <a:gd name="connsiteY20" fmla="*/ 8 h 175547"/>
                <a:gd name="connsiteX21" fmla="*/ 7513320 w 8420100"/>
                <a:gd name="connsiteY21" fmla="*/ 144788 h 175547"/>
                <a:gd name="connsiteX22" fmla="*/ 7871460 w 8420100"/>
                <a:gd name="connsiteY22" fmla="*/ 7628 h 175547"/>
                <a:gd name="connsiteX23" fmla="*/ 8420100 w 8420100"/>
                <a:gd name="connsiteY23" fmla="*/ 30488 h 175547"/>
                <a:gd name="connsiteX0" fmla="*/ 0 w 8465820"/>
                <a:gd name="connsiteY0" fmla="*/ 7620 h 160028"/>
                <a:gd name="connsiteX1" fmla="*/ 320040 w 8465820"/>
                <a:gd name="connsiteY1" fmla="*/ 152400 h 160028"/>
                <a:gd name="connsiteX2" fmla="*/ 693420 w 8465820"/>
                <a:gd name="connsiteY2" fmla="*/ 7620 h 160028"/>
                <a:gd name="connsiteX3" fmla="*/ 1059180 w 8465820"/>
                <a:gd name="connsiteY3" fmla="*/ 152400 h 160028"/>
                <a:gd name="connsiteX4" fmla="*/ 1409700 w 8465820"/>
                <a:gd name="connsiteY4" fmla="*/ 15240 h 160028"/>
                <a:gd name="connsiteX5" fmla="*/ 1767840 w 8465820"/>
                <a:gd name="connsiteY5" fmla="*/ 152400 h 160028"/>
                <a:gd name="connsiteX6" fmla="*/ 2118360 w 8465820"/>
                <a:gd name="connsiteY6" fmla="*/ 15240 h 160028"/>
                <a:gd name="connsiteX7" fmla="*/ 2484120 w 8465820"/>
                <a:gd name="connsiteY7" fmla="*/ 160020 h 160028"/>
                <a:gd name="connsiteX8" fmla="*/ 2842260 w 8465820"/>
                <a:gd name="connsiteY8" fmla="*/ 22860 h 160028"/>
                <a:gd name="connsiteX9" fmla="*/ 3200400 w 8465820"/>
                <a:gd name="connsiteY9" fmla="*/ 152400 h 160028"/>
                <a:gd name="connsiteX10" fmla="*/ 3566160 w 8465820"/>
                <a:gd name="connsiteY10" fmla="*/ 22860 h 160028"/>
                <a:gd name="connsiteX11" fmla="*/ 3916680 w 8465820"/>
                <a:gd name="connsiteY11" fmla="*/ 152400 h 160028"/>
                <a:gd name="connsiteX12" fmla="*/ 4282440 w 8465820"/>
                <a:gd name="connsiteY12" fmla="*/ 15240 h 160028"/>
                <a:gd name="connsiteX13" fmla="*/ 4640580 w 8465820"/>
                <a:gd name="connsiteY13" fmla="*/ 152400 h 160028"/>
                <a:gd name="connsiteX14" fmla="*/ 4998720 w 8465820"/>
                <a:gd name="connsiteY14" fmla="*/ 15240 h 160028"/>
                <a:gd name="connsiteX15" fmla="*/ 5364480 w 8465820"/>
                <a:gd name="connsiteY15" fmla="*/ 144780 h 160028"/>
                <a:gd name="connsiteX16" fmla="*/ 5722620 w 8465820"/>
                <a:gd name="connsiteY16" fmla="*/ 15240 h 160028"/>
                <a:gd name="connsiteX17" fmla="*/ 6088380 w 8465820"/>
                <a:gd name="connsiteY17" fmla="*/ 152400 h 160028"/>
                <a:gd name="connsiteX18" fmla="*/ 6438900 w 8465820"/>
                <a:gd name="connsiteY18" fmla="*/ 15240 h 160028"/>
                <a:gd name="connsiteX19" fmla="*/ 6804660 w 8465820"/>
                <a:gd name="connsiteY19" fmla="*/ 144780 h 160028"/>
                <a:gd name="connsiteX20" fmla="*/ 7155180 w 8465820"/>
                <a:gd name="connsiteY20" fmla="*/ 7620 h 160028"/>
                <a:gd name="connsiteX21" fmla="*/ 7513320 w 8465820"/>
                <a:gd name="connsiteY21" fmla="*/ 152400 h 160028"/>
                <a:gd name="connsiteX22" fmla="*/ 7871460 w 8465820"/>
                <a:gd name="connsiteY22" fmla="*/ 15240 h 160028"/>
                <a:gd name="connsiteX23" fmla="*/ 8465820 w 8465820"/>
                <a:gd name="connsiteY23" fmla="*/ 0 h 1600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</a:cxnLst>
              <a:rect l="l" t="t" r="r" b="b"/>
              <a:pathLst>
                <a:path w="8465820" h="160028">
                  <a:moveTo>
                    <a:pt x="0" y="7620"/>
                  </a:moveTo>
                  <a:cubicBezTo>
                    <a:pt x="102235" y="80010"/>
                    <a:pt x="204470" y="152400"/>
                    <a:pt x="320040" y="152400"/>
                  </a:cubicBezTo>
                  <a:cubicBezTo>
                    <a:pt x="435610" y="152400"/>
                    <a:pt x="570230" y="7620"/>
                    <a:pt x="693420" y="7620"/>
                  </a:cubicBezTo>
                  <a:cubicBezTo>
                    <a:pt x="816610" y="7620"/>
                    <a:pt x="939800" y="151130"/>
                    <a:pt x="1059180" y="152400"/>
                  </a:cubicBezTo>
                  <a:cubicBezTo>
                    <a:pt x="1178560" y="153670"/>
                    <a:pt x="1291590" y="15240"/>
                    <a:pt x="1409700" y="15240"/>
                  </a:cubicBezTo>
                  <a:cubicBezTo>
                    <a:pt x="1527810" y="15240"/>
                    <a:pt x="1649730" y="152400"/>
                    <a:pt x="1767840" y="152400"/>
                  </a:cubicBezTo>
                  <a:cubicBezTo>
                    <a:pt x="1885950" y="152400"/>
                    <a:pt x="1998980" y="13970"/>
                    <a:pt x="2118360" y="15240"/>
                  </a:cubicBezTo>
                  <a:cubicBezTo>
                    <a:pt x="2237740" y="16510"/>
                    <a:pt x="2363470" y="158750"/>
                    <a:pt x="2484120" y="160020"/>
                  </a:cubicBezTo>
                  <a:cubicBezTo>
                    <a:pt x="2604770" y="161290"/>
                    <a:pt x="2722880" y="24130"/>
                    <a:pt x="2842260" y="22860"/>
                  </a:cubicBezTo>
                  <a:cubicBezTo>
                    <a:pt x="2961640" y="21590"/>
                    <a:pt x="3079750" y="152400"/>
                    <a:pt x="3200400" y="152400"/>
                  </a:cubicBezTo>
                  <a:cubicBezTo>
                    <a:pt x="3321050" y="152400"/>
                    <a:pt x="3446780" y="22860"/>
                    <a:pt x="3566160" y="22860"/>
                  </a:cubicBezTo>
                  <a:cubicBezTo>
                    <a:pt x="3685540" y="22860"/>
                    <a:pt x="3797300" y="153670"/>
                    <a:pt x="3916680" y="152400"/>
                  </a:cubicBezTo>
                  <a:cubicBezTo>
                    <a:pt x="4036060" y="151130"/>
                    <a:pt x="4161790" y="15240"/>
                    <a:pt x="4282440" y="15240"/>
                  </a:cubicBezTo>
                  <a:cubicBezTo>
                    <a:pt x="4403090" y="15240"/>
                    <a:pt x="4521200" y="152400"/>
                    <a:pt x="4640580" y="152400"/>
                  </a:cubicBezTo>
                  <a:cubicBezTo>
                    <a:pt x="4759960" y="152400"/>
                    <a:pt x="4878070" y="16510"/>
                    <a:pt x="4998720" y="15240"/>
                  </a:cubicBezTo>
                  <a:cubicBezTo>
                    <a:pt x="5119370" y="13970"/>
                    <a:pt x="5243830" y="144780"/>
                    <a:pt x="5364480" y="144780"/>
                  </a:cubicBezTo>
                  <a:cubicBezTo>
                    <a:pt x="5485130" y="144780"/>
                    <a:pt x="5601970" y="13970"/>
                    <a:pt x="5722620" y="15240"/>
                  </a:cubicBezTo>
                  <a:cubicBezTo>
                    <a:pt x="5843270" y="16510"/>
                    <a:pt x="5969000" y="152400"/>
                    <a:pt x="6088380" y="152400"/>
                  </a:cubicBezTo>
                  <a:cubicBezTo>
                    <a:pt x="6207760" y="152400"/>
                    <a:pt x="6319520" y="16510"/>
                    <a:pt x="6438900" y="15240"/>
                  </a:cubicBezTo>
                  <a:cubicBezTo>
                    <a:pt x="6558280" y="13970"/>
                    <a:pt x="6685280" y="146050"/>
                    <a:pt x="6804660" y="144780"/>
                  </a:cubicBezTo>
                  <a:cubicBezTo>
                    <a:pt x="6924040" y="143510"/>
                    <a:pt x="7037070" y="6350"/>
                    <a:pt x="7155180" y="7620"/>
                  </a:cubicBezTo>
                  <a:cubicBezTo>
                    <a:pt x="7273290" y="8890"/>
                    <a:pt x="7393940" y="151130"/>
                    <a:pt x="7513320" y="152400"/>
                  </a:cubicBezTo>
                  <a:cubicBezTo>
                    <a:pt x="7632700" y="153670"/>
                    <a:pt x="7712710" y="40640"/>
                    <a:pt x="7871460" y="15240"/>
                  </a:cubicBezTo>
                  <a:cubicBezTo>
                    <a:pt x="8030210" y="-10160"/>
                    <a:pt x="8115300" y="347980"/>
                    <a:pt x="8465820" y="0"/>
                  </a:cubicBezTo>
                </a:path>
              </a:pathLst>
            </a:custGeom>
            <a:ln w="1016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226973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</TotalTime>
  <Words>2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노송휘[ 강사 / 간호학과 ]</dc:creator>
  <cp:lastModifiedBy>CE</cp:lastModifiedBy>
  <cp:revision>36</cp:revision>
  <cp:lastPrinted>2025-03-04T01:54:54Z</cp:lastPrinted>
  <dcterms:created xsi:type="dcterms:W3CDTF">2024-08-23T08:31:52Z</dcterms:created>
  <dcterms:modified xsi:type="dcterms:W3CDTF">2025-04-18T19:30:25Z</dcterms:modified>
</cp:coreProperties>
</file>